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7196138" cy="899795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34">
          <p15:clr>
            <a:srgbClr val="A4A3A4"/>
          </p15:clr>
        </p15:guide>
        <p15:guide id="2" pos="2267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14286" autoAdjust="0"/>
    <p:restoredTop sz="98182" autoAdjust="0"/>
  </p:normalViewPr>
  <p:slideViewPr>
    <p:cSldViewPr snapToGrid="0" snapToObjects="1">
      <p:cViewPr varScale="1">
        <p:scale>
          <a:sx n="100" d="100"/>
          <a:sy n="100" d="100"/>
        </p:scale>
        <p:origin x="4112" y="168"/>
      </p:cViewPr>
      <p:guideLst>
        <p:guide orient="horz" pos="2834"/>
        <p:guide pos="2267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39711" y="2795197"/>
            <a:ext cx="6116717" cy="192872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79421" y="5098838"/>
            <a:ext cx="5037297" cy="2299476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711552-26A8-F34F-8CA5-E27A39ED69A7}" type="datetimeFigureOut">
              <a:rPr lang="en-US" smtClean="0"/>
              <a:t>8/1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CE9CEE-7343-1A47-A297-6BA5854F08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87610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711552-26A8-F34F-8CA5-E27A39ED69A7}" type="datetimeFigureOut">
              <a:rPr lang="en-US" smtClean="0"/>
              <a:t>8/1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CE9CEE-7343-1A47-A297-6BA5854F08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78288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106547" y="472810"/>
            <a:ext cx="1273066" cy="1007270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83598" y="472810"/>
            <a:ext cx="3703013" cy="1007270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711552-26A8-F34F-8CA5-E27A39ED69A7}" type="datetimeFigureOut">
              <a:rPr lang="en-US" smtClean="0"/>
              <a:t>8/1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CE9CEE-7343-1A47-A297-6BA5854F08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2428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711552-26A8-F34F-8CA5-E27A39ED69A7}" type="datetimeFigureOut">
              <a:rPr lang="en-US" smtClean="0"/>
              <a:t>8/1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CE9CEE-7343-1A47-A297-6BA5854F08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4166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8445" y="5782017"/>
            <a:ext cx="6116717" cy="1787093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68445" y="3813716"/>
            <a:ext cx="6116717" cy="1968301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711552-26A8-F34F-8CA5-E27A39ED69A7}" type="datetimeFigureOut">
              <a:rPr lang="en-US" smtClean="0"/>
              <a:t>8/1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CE9CEE-7343-1A47-A297-6BA5854F08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02656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83598" y="2755623"/>
            <a:ext cx="2487415" cy="778989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890949" y="2755623"/>
            <a:ext cx="2488664" cy="778989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711552-26A8-F34F-8CA5-E27A39ED69A7}" type="datetimeFigureOut">
              <a:rPr lang="en-US" smtClean="0"/>
              <a:t>8/11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CE9CEE-7343-1A47-A297-6BA5854F08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80732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59807" y="360335"/>
            <a:ext cx="6476524" cy="1499658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59807" y="2014125"/>
            <a:ext cx="3179544" cy="83939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9807" y="2853517"/>
            <a:ext cx="3179544" cy="518423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655539" y="2014125"/>
            <a:ext cx="3180793" cy="83939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655539" y="2853517"/>
            <a:ext cx="3180793" cy="518423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711552-26A8-F34F-8CA5-E27A39ED69A7}" type="datetimeFigureOut">
              <a:rPr lang="en-US" smtClean="0"/>
              <a:t>8/11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CE9CEE-7343-1A47-A297-6BA5854F08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80977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711552-26A8-F34F-8CA5-E27A39ED69A7}" type="datetimeFigureOut">
              <a:rPr lang="en-US" smtClean="0"/>
              <a:t>8/11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CE9CEE-7343-1A47-A297-6BA5854F08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3924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711552-26A8-F34F-8CA5-E27A39ED69A7}" type="datetimeFigureOut">
              <a:rPr lang="en-US" smtClean="0"/>
              <a:t>8/11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CE9CEE-7343-1A47-A297-6BA5854F08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3179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59807" y="358252"/>
            <a:ext cx="2367480" cy="1524653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813490" y="358252"/>
            <a:ext cx="4022841" cy="767950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59807" y="1882905"/>
            <a:ext cx="2367480" cy="615484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711552-26A8-F34F-8CA5-E27A39ED69A7}" type="datetimeFigureOut">
              <a:rPr lang="en-US" smtClean="0"/>
              <a:t>8/11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CE9CEE-7343-1A47-A297-6BA5854F08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2332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10493" y="6298565"/>
            <a:ext cx="4317683" cy="74358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410493" y="803983"/>
            <a:ext cx="4317683" cy="539877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410493" y="7042146"/>
            <a:ext cx="4317683" cy="105600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711552-26A8-F34F-8CA5-E27A39ED69A7}" type="datetimeFigureOut">
              <a:rPr lang="en-US" smtClean="0"/>
              <a:t>8/11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CE9CEE-7343-1A47-A297-6BA5854F08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46960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59807" y="360335"/>
            <a:ext cx="6476524" cy="149965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59807" y="2099522"/>
            <a:ext cx="6476524" cy="593823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59807" y="8339767"/>
            <a:ext cx="1679099" cy="47905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711552-26A8-F34F-8CA5-E27A39ED69A7}" type="datetimeFigureOut">
              <a:rPr lang="en-US" smtClean="0"/>
              <a:t>8/1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58681" y="8339767"/>
            <a:ext cx="2278777" cy="47905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157232" y="8339767"/>
            <a:ext cx="1679099" cy="47905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CE9CEE-7343-1A47-A297-6BA5854F08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67216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4" Type="http://schemas.openxmlformats.org/officeDocument/2006/relationships/image" Target="../media/image3.emf"/><Relationship Id="rId5" Type="http://schemas.openxmlformats.org/officeDocument/2006/relationships/image" Target="../media/image4.emf"/><Relationship Id="rId6" Type="http://schemas.openxmlformats.org/officeDocument/2006/relationships/image" Target="../media/image5.emf"/><Relationship Id="rId7" Type="http://schemas.openxmlformats.org/officeDocument/2006/relationships/image" Target="../media/image6.emf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71640" y="296542"/>
            <a:ext cx="2745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Times New Roman"/>
                <a:cs typeface="Times New Roman"/>
              </a:rPr>
              <a:t>A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446215" y="342708"/>
            <a:ext cx="260581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Times New Roman"/>
                <a:cs typeface="Times New Roman"/>
              </a:rPr>
              <a:t>OK107/+ flies have wild-type memory retention</a:t>
            </a:r>
            <a:endParaRPr lang="en-US" sz="1200" i="1" dirty="0">
              <a:latin typeface="Times New Roman"/>
              <a:cs typeface="Times New Roman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3293469" y="296542"/>
            <a:ext cx="2745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Times New Roman"/>
                <a:cs typeface="Times New Roman"/>
              </a:rPr>
              <a:t>B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688194" y="342708"/>
            <a:ext cx="260581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Times New Roman"/>
                <a:cs typeface="Times New Roman"/>
              </a:rPr>
              <a:t>MB247/+ flies have show memory retention</a:t>
            </a:r>
            <a:endParaRPr lang="en-US" sz="1200" i="1" dirty="0">
              <a:latin typeface="Times New Roman"/>
              <a:cs typeface="Times New Roman"/>
            </a:endParaRPr>
          </a:p>
        </p:txBody>
      </p:sp>
      <p:sp>
        <p:nvSpPr>
          <p:cNvPr id="8" name="TextBox 7"/>
          <p:cNvSpPr txBox="1"/>
          <p:nvPr/>
        </p:nvSpPr>
        <p:spPr>
          <a:xfrm rot="16200000">
            <a:off x="-786373" y="1634488"/>
            <a:ext cx="212189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Times New Roman"/>
                <a:cs typeface="Times New Roman"/>
              </a:rPr>
              <a:t>Proportion of eggs laid on 6% </a:t>
            </a:r>
            <a:r>
              <a:rPr lang="en-US" sz="1200" dirty="0" err="1" smtClean="0">
                <a:latin typeface="Times New Roman"/>
                <a:cs typeface="Times New Roman"/>
              </a:rPr>
              <a:t>EtOH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505408" y="3189773"/>
            <a:ext cx="260581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i="1" dirty="0" err="1" smtClean="0">
                <a:latin typeface="Times New Roman"/>
                <a:cs typeface="Times New Roman"/>
              </a:rPr>
              <a:t>Gug</a:t>
            </a:r>
            <a:r>
              <a:rPr lang="en-US" sz="1200" baseline="30000" dirty="0" err="1" smtClean="0">
                <a:latin typeface="Times New Roman"/>
                <a:cs typeface="Times New Roman"/>
              </a:rPr>
              <a:t>RNAi</a:t>
            </a:r>
            <a:r>
              <a:rPr lang="en-US" sz="1200" dirty="0" smtClean="0">
                <a:latin typeface="Times New Roman"/>
                <a:cs typeface="Times New Roman"/>
              </a:rPr>
              <a:t>/+ flies have wild-type memory retention</a:t>
            </a:r>
            <a:endParaRPr lang="en-US" sz="1200" i="1" dirty="0">
              <a:latin typeface="Times New Roman"/>
              <a:cs typeface="Times New Roman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3747387" y="3189773"/>
            <a:ext cx="260581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err="1" smtClean="0">
                <a:latin typeface="Times New Roman"/>
                <a:cs typeface="Times New Roman"/>
              </a:rPr>
              <a:t>MBswitch</a:t>
            </a:r>
            <a:r>
              <a:rPr lang="en-US" sz="1200" dirty="0" smtClean="0">
                <a:latin typeface="Times New Roman"/>
                <a:cs typeface="Times New Roman"/>
              </a:rPr>
              <a:t>/+ flies fed RU486 have wild-type memory retention</a:t>
            </a:r>
            <a:endParaRPr lang="en-US" sz="1200" i="1" dirty="0">
              <a:latin typeface="Times New Roman"/>
              <a:cs typeface="Times New Roman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171640" y="3189773"/>
            <a:ext cx="2745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Times New Roman"/>
                <a:cs typeface="Times New Roman"/>
              </a:rPr>
              <a:t>C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3293469" y="3189773"/>
            <a:ext cx="2745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/>
                <a:cs typeface="Times New Roman"/>
              </a:rPr>
              <a:t>D</a:t>
            </a:r>
          </a:p>
        </p:txBody>
      </p:sp>
      <p:sp>
        <p:nvSpPr>
          <p:cNvPr id="13" name="TextBox 12"/>
          <p:cNvSpPr txBox="1"/>
          <p:nvPr/>
        </p:nvSpPr>
        <p:spPr>
          <a:xfrm rot="16200000">
            <a:off x="-786373" y="4527719"/>
            <a:ext cx="212189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Times New Roman"/>
                <a:cs typeface="Times New Roman"/>
              </a:rPr>
              <a:t>Proportion of eggs laid on 6% </a:t>
            </a:r>
            <a:r>
              <a:rPr lang="en-US" sz="1200" dirty="0" err="1" smtClean="0">
                <a:latin typeface="Times New Roman"/>
                <a:cs typeface="Times New Roman"/>
              </a:rPr>
              <a:t>EtOH</a:t>
            </a:r>
            <a:endParaRPr lang="en-US" sz="1200" dirty="0">
              <a:latin typeface="Times New Roman"/>
              <a:cs typeface="Times New Roman"/>
            </a:endParaRPr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 rotWithShape="1">
          <a:blip r:embed="rId2"/>
          <a:srcRect l="82767" t="51671" r="1729" b="40726"/>
          <a:stretch/>
        </p:blipFill>
        <p:spPr>
          <a:xfrm>
            <a:off x="2331076" y="5819500"/>
            <a:ext cx="1115680" cy="410839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 rotWithShape="1">
          <a:blip r:embed="rId3"/>
          <a:srcRect l="82767" t="58301" r="1729" b="35623"/>
          <a:stretch/>
        </p:blipFill>
        <p:spPr>
          <a:xfrm>
            <a:off x="3688194" y="5893147"/>
            <a:ext cx="1115680" cy="328326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46215" y="3716380"/>
            <a:ext cx="2802541" cy="2103120"/>
          </a:xfrm>
          <a:prstGeom prst="rect">
            <a:avLst/>
          </a:prstGeom>
        </p:spPr>
      </p:pic>
      <p:sp>
        <p:nvSpPr>
          <p:cNvPr id="17" name="TextBox 16"/>
          <p:cNvSpPr txBox="1"/>
          <p:nvPr/>
        </p:nvSpPr>
        <p:spPr>
          <a:xfrm>
            <a:off x="1073195" y="3733314"/>
            <a:ext cx="2745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Times New Roman"/>
                <a:cs typeface="Times New Roman"/>
              </a:rPr>
              <a:t>*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1919419" y="3724847"/>
            <a:ext cx="2745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Times New Roman"/>
                <a:cs typeface="Times New Roman"/>
              </a:rPr>
              <a:t>*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2749103" y="3689136"/>
            <a:ext cx="2745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Times New Roman"/>
                <a:cs typeface="Times New Roman"/>
              </a:rPr>
              <a:t>*</a:t>
            </a:r>
            <a:endParaRPr lang="en-US" sz="1200" dirty="0">
              <a:latin typeface="Times New Roman"/>
              <a:cs typeface="Times New Roman"/>
            </a:endParaRPr>
          </a:p>
        </p:txBody>
      </p:sp>
      <p:pic>
        <p:nvPicPr>
          <p:cNvPr id="20" name="Picture 19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688194" y="3716380"/>
            <a:ext cx="2802541" cy="2103120"/>
          </a:xfrm>
          <a:prstGeom prst="rect">
            <a:avLst/>
          </a:prstGeom>
        </p:spPr>
      </p:pic>
      <p:sp>
        <p:nvSpPr>
          <p:cNvPr id="21" name="TextBox 20"/>
          <p:cNvSpPr txBox="1"/>
          <p:nvPr/>
        </p:nvSpPr>
        <p:spPr>
          <a:xfrm>
            <a:off x="4315701" y="3738747"/>
            <a:ext cx="2745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Times New Roman"/>
                <a:cs typeface="Times New Roman"/>
              </a:rPr>
              <a:t>*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5162316" y="3724847"/>
            <a:ext cx="2745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Times New Roman"/>
                <a:cs typeface="Times New Roman"/>
              </a:rPr>
              <a:t>*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6002503" y="3699446"/>
            <a:ext cx="2745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Times New Roman"/>
                <a:cs typeface="Times New Roman"/>
              </a:rPr>
              <a:t>*</a:t>
            </a:r>
            <a:endParaRPr lang="en-US" sz="1200" dirty="0">
              <a:latin typeface="Times New Roman"/>
              <a:cs typeface="Times New Roman"/>
            </a:endParaRPr>
          </a:p>
        </p:txBody>
      </p:sp>
      <p:pic>
        <p:nvPicPr>
          <p:cNvPr id="25" name="Picture 24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46215" y="823149"/>
            <a:ext cx="2804160" cy="2103120"/>
          </a:xfrm>
          <a:prstGeom prst="rect">
            <a:avLst/>
          </a:prstGeom>
        </p:spPr>
      </p:pic>
      <p:pic>
        <p:nvPicPr>
          <p:cNvPr id="26" name="Picture 25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688194" y="823149"/>
            <a:ext cx="2804160" cy="2103120"/>
          </a:xfrm>
          <a:prstGeom prst="rect">
            <a:avLst/>
          </a:prstGeom>
        </p:spPr>
      </p:pic>
      <p:sp>
        <p:nvSpPr>
          <p:cNvPr id="27" name="TextBox 26"/>
          <p:cNvSpPr txBox="1"/>
          <p:nvPr/>
        </p:nvSpPr>
        <p:spPr>
          <a:xfrm>
            <a:off x="1081661" y="804372"/>
            <a:ext cx="2745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Times New Roman"/>
                <a:cs typeface="Times New Roman"/>
              </a:rPr>
              <a:t>*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919419" y="872143"/>
            <a:ext cx="2745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Times New Roman"/>
                <a:cs typeface="Times New Roman"/>
              </a:rPr>
              <a:t>*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2749103" y="804407"/>
            <a:ext cx="2745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Times New Roman"/>
                <a:cs typeface="Times New Roman"/>
              </a:rPr>
              <a:t>*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4315701" y="844343"/>
            <a:ext cx="2745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Times New Roman"/>
                <a:cs typeface="Times New Roman"/>
              </a:rPr>
              <a:t>*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5153850" y="849776"/>
            <a:ext cx="2745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Times New Roman"/>
                <a:cs typeface="Times New Roman"/>
              </a:rPr>
              <a:t>*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5994037" y="878247"/>
            <a:ext cx="2745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Times New Roman"/>
                <a:cs typeface="Times New Roman"/>
              </a:rPr>
              <a:t>*</a:t>
            </a:r>
            <a:endParaRPr lang="en-US" sz="1200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41188374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</TotalTime>
  <Words>62</Words>
  <Application>Microsoft Macintosh PowerPoint</Application>
  <PresentationFormat>Custom</PresentationFormat>
  <Paragraphs>2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Calibri</vt:lpstr>
      <vt:lpstr>Times New Roman</vt:lpstr>
      <vt:lpstr>Arial</vt:lpstr>
      <vt:lpstr>Office Theme</vt:lpstr>
      <vt:lpstr>PowerPoint Presentation</vt:lpstr>
    </vt:vector>
  </TitlesOfParts>
  <Company>Home</Company>
  <LinksUpToDate>false</LinksUpToDate>
  <SharedDoc>false</SharedDoc>
  <HyperlinksChanged>false</HyperlinksChanged>
  <AppVersion>15.003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lint Kacsoh</dc:creator>
  <cp:lastModifiedBy>Balint Kacsoh</cp:lastModifiedBy>
  <cp:revision>6</cp:revision>
  <dcterms:created xsi:type="dcterms:W3CDTF">2017-06-06T17:56:50Z</dcterms:created>
  <dcterms:modified xsi:type="dcterms:W3CDTF">2017-08-11T20:23:43Z</dcterms:modified>
</cp:coreProperties>
</file>